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6"/>
  </p:notesMasterIdLst>
  <p:sldIdLst>
    <p:sldId id="278" r:id="rId5"/>
    <p:sldId id="325" r:id="rId6"/>
    <p:sldId id="359" r:id="rId7"/>
    <p:sldId id="279" r:id="rId8"/>
    <p:sldId id="344" r:id="rId9"/>
    <p:sldId id="335" r:id="rId10"/>
    <p:sldId id="321" r:id="rId11"/>
    <p:sldId id="357" r:id="rId12"/>
    <p:sldId id="315" r:id="rId13"/>
    <p:sldId id="349" r:id="rId14"/>
    <p:sldId id="358" r:id="rId1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91F9DB0-C7B0-4159-B9D8-7F583E0AC2E4}">
          <p14:sldIdLst>
            <p14:sldId id="278"/>
            <p14:sldId id="325"/>
            <p14:sldId id="359"/>
            <p14:sldId id="279"/>
            <p14:sldId id="344"/>
            <p14:sldId id="335"/>
            <p14:sldId id="321"/>
            <p14:sldId id="357"/>
            <p14:sldId id="315"/>
            <p14:sldId id="349"/>
            <p14:sldId id="35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8E05D0A-AC2C-241D-D457-9D2C222587CD}" name="Bergamino Sirven, Milana Arantza" initials="BA" userId="S::mabergamino@iconcologia.net::f941bcbf-953f-4f8f-b7a5-568726d74ec1" providerId="AD"/>
  <p188:author id="{D8FB773E-9075-5638-558C-2274343B0DE4}" name="Maggie Cheang" initials="MC" userId="S::maggie.cheang@icr.ac.uk::11e447ef-d00b-49e3-8adb-9a60ea9e0937" providerId="AD"/>
  <p188:author id="{BFE9E459-2AB3-E2DA-D073-AC76009A1B20}" name="Elena Lopez Knowles" initials="EK" userId="S::elena.lopezknowles_icr.ac.uk#ext#@gencat.onmicrosoft.com::544f014a-867d-4d7b-847a-f3927a416517" providerId="AD"/>
  <p188:author id="{460A918E-BD0C-0F89-C99A-CA91B28865FB}" name="Maggie Cheang" initials="MC" userId="S::Maggie.Cheang@icr.ac.uk::11e447ef-d00b-49e3-8adb-9a60ea9e0937" providerId="AD"/>
  <p188:author id="{F2A14CF0-8C2C-B676-3110-92EB19B4B310}" name="Xixuan Zhu" initials="" userId="S::xixuan.zhu@icr.ac.uk::0aa82303-faee-4a25-a001-10d33503fad8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ena Lopez Knowles" initials="ELK" lastIdx="7" clrIdx="0">
    <p:extLst>
      <p:ext uri="{19B8F6BF-5375-455C-9EA6-DF929625EA0E}">
        <p15:presenceInfo xmlns:p15="http://schemas.microsoft.com/office/powerpoint/2012/main" userId="S-1-5-21-2720991719-3395378957-1752411362-7975" providerId="AD"/>
      </p:ext>
    </p:extLst>
  </p:cmAuthor>
  <p:cmAuthor id="2" name="Milana Arantza Bergamino Sirven" initials="MABS" lastIdx="1" clrIdx="1">
    <p:extLst>
      <p:ext uri="{19B8F6BF-5375-455C-9EA6-DF929625EA0E}">
        <p15:presenceInfo xmlns:p15="http://schemas.microsoft.com/office/powerpoint/2012/main" userId="Milana Arantza Bergamino Sirv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CC"/>
    <a:srgbClr val="FF0000"/>
    <a:srgbClr val="FFC0CB"/>
    <a:srgbClr val="0000FF"/>
    <a:srgbClr val="FFA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C8EB4E6-0869-B546-BF3D-1DE96A907B15}" v="33" dt="2025-03-11T13:56:40.53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Estilo medio 2 - Énfasis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Estilo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FECB4D8-DB02-4DC6-A0A2-4F2EBAE1DC90}" styleName="Estilo medio 1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7853C-536D-4A76-A0AE-DD22124D55A5}" styleName="Estilo temático 1 - Énfasis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505E3EF-67EA-436B-97B2-0124C06EBD24}" styleName="Estilo medio 4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8799B23B-EC83-4686-B30A-512413B5E67A}" styleName="Estilo claro 3 - Acent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9631B5-78F2-41C9-869B-9F39066F8104}" styleName="Estilo medio 3 - 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Estilo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ABFCF23-3B69-468F-B69F-88F6DE6A72F2}" styleName="Estilo medio 1 - Énfasis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0A1B5D5-9B99-4C35-A422-299274C87663}" styleName="Estilo medio 1 - Énfasis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906"/>
    <p:restoredTop sz="94694"/>
  </p:normalViewPr>
  <p:slideViewPr>
    <p:cSldViewPr snapToGrid="0">
      <p:cViewPr>
        <p:scale>
          <a:sx n="123" d="100"/>
          <a:sy n="123" d="100"/>
        </p:scale>
        <p:origin x="183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8/10/relationships/authors" Target="authors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AA3E57-A746-4D86-A2F2-0B299F75CC72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A3C7AD-35AD-423D-A109-61B42F86EE63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8112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8664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1· TAKE HOME MESSAGE: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mographic characteristics are well balanced</a:t>
            </a:r>
            <a:endParaRPr lang="en-GB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97480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/>
              <a:t>Would like to review the text describing these figures</a:t>
            </a:r>
          </a:p>
          <a:p>
            <a:pPr marL="171450" indent="-171450">
              <a:buFontTx/>
              <a:buChar char="-"/>
            </a:pPr>
            <a:endParaRPr lang="en-US"/>
          </a:p>
          <a:p>
            <a:pPr marL="171450" indent="-171450">
              <a:buFontTx/>
              <a:buChar char="-"/>
            </a:pPr>
            <a:r>
              <a:rPr lang="en-US"/>
              <a:t>Question – re those shifting to the 2</a:t>
            </a:r>
            <a:r>
              <a:rPr lang="en-US" baseline="30000"/>
              <a:t>nd</a:t>
            </a:r>
            <a:r>
              <a:rPr lang="en-US"/>
              <a:t> highest correlation at baseline (a panel) – what are the % of each shifting? </a:t>
            </a:r>
            <a:r>
              <a:rPr lang="en-US" err="1"/>
              <a:t>Eg.</a:t>
            </a:r>
            <a:r>
              <a:rPr lang="en-US"/>
              <a:t> I suspect more </a:t>
            </a:r>
            <a:r>
              <a:rPr lang="en-US" err="1"/>
              <a:t>LumB</a:t>
            </a:r>
            <a:r>
              <a:rPr lang="en-US"/>
              <a:t> – </a:t>
            </a:r>
            <a:r>
              <a:rPr lang="en-US" err="1"/>
              <a:t>LumA</a:t>
            </a:r>
            <a:r>
              <a:rPr lang="en-US"/>
              <a:t> rather than HER2-E to </a:t>
            </a:r>
            <a:r>
              <a:rPr lang="en-US" err="1"/>
              <a:t>lumA</a:t>
            </a:r>
            <a:r>
              <a:rPr lang="en-US"/>
              <a:t>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58086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777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298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1122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6128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420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033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590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451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75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3678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94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745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363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E049-77F2-42AD-99FD-C8D54F26BDBF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5368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14790BB8-E52B-AD50-5DA5-1877F22EBA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783" y="545836"/>
            <a:ext cx="640711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>
                <a:ln>
                  <a:noFill/>
                </a:ln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S1.</a:t>
            </a:r>
            <a:endParaRPr lang="en-GB" sz="1200" b="0" i="0" u="none" strike="noStrike" cap="none" normalizeH="0" baseline="0" dirty="0">
              <a:ln>
                <a:noFill/>
              </a:ln>
              <a:effectLst/>
              <a:latin typeface="Times New Roman"/>
              <a:cs typeface="Times New Roman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3DE33D7-35A7-5526-4C3A-7806FDB78286}"/>
              </a:ext>
            </a:extLst>
          </p:cNvPr>
          <p:cNvGrpSpPr/>
          <p:nvPr/>
        </p:nvGrpSpPr>
        <p:grpSpPr>
          <a:xfrm>
            <a:off x="200673" y="1046559"/>
            <a:ext cx="6931650" cy="4039567"/>
            <a:chOff x="200673" y="1708635"/>
            <a:chExt cx="6931650" cy="4039567"/>
          </a:xfrm>
        </p:grpSpPr>
        <p:sp>
          <p:nvSpPr>
            <p:cNvPr id="5" name="Rectangle 3">
              <a:extLst>
                <a:ext uri="{FF2B5EF4-FFF2-40B4-BE49-F238E27FC236}">
                  <a16:creationId xmlns:a16="http://schemas.microsoft.com/office/drawing/2014/main" id="{486A9FA3-FA70-D273-291F-AB52A47487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3183" y="4780960"/>
              <a:ext cx="18473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GB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uadroTexto 4">
              <a:extLst>
                <a:ext uri="{FF2B5EF4-FFF2-40B4-BE49-F238E27FC236}">
                  <a16:creationId xmlns:a16="http://schemas.microsoft.com/office/drawing/2014/main" id="{8E716069-057A-5BF5-5D0E-D1877490F364}"/>
                </a:ext>
              </a:extLst>
            </p:cNvPr>
            <p:cNvSpPr txBox="1"/>
            <p:nvPr/>
          </p:nvSpPr>
          <p:spPr>
            <a:xfrm>
              <a:off x="1663929" y="1708635"/>
              <a:ext cx="2155797" cy="2616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4480 ER+ BC patients in POETIC</a:t>
              </a:r>
            </a:p>
          </p:txBody>
        </p:sp>
        <p:sp>
          <p:nvSpPr>
            <p:cNvPr id="8" name="CuadroTexto 5">
              <a:extLst>
                <a:ext uri="{FF2B5EF4-FFF2-40B4-BE49-F238E27FC236}">
                  <a16:creationId xmlns:a16="http://schemas.microsoft.com/office/drawing/2014/main" id="{080D7961-B9D3-DAE6-C858-FB313B4BB437}"/>
                </a:ext>
              </a:extLst>
            </p:cNvPr>
            <p:cNvSpPr txBox="1"/>
            <p:nvPr/>
          </p:nvSpPr>
          <p:spPr>
            <a:xfrm>
              <a:off x="2224309" y="2164488"/>
              <a:ext cx="1145026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>
                  <a:latin typeface="Times New Roman"/>
                  <a:cs typeface="Times New Roman"/>
                </a:rPr>
                <a:t>HER2+ BC 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100">
                  <a:latin typeface="Times New Roman"/>
                  <a:cs typeface="Times New Roman"/>
                </a:rPr>
                <a:t>n= 468 patients</a:t>
              </a:r>
            </a:p>
          </p:txBody>
        </p:sp>
        <p:sp>
          <p:nvSpPr>
            <p:cNvPr id="9" name="CuadroTexto 6">
              <a:extLst>
                <a:ext uri="{FF2B5EF4-FFF2-40B4-BE49-F238E27FC236}">
                  <a16:creationId xmlns:a16="http://schemas.microsoft.com/office/drawing/2014/main" id="{2BE612FB-5E36-89F6-DDA5-24100CC76854}"/>
                </a:ext>
              </a:extLst>
            </p:cNvPr>
            <p:cNvSpPr txBox="1"/>
            <p:nvPr/>
          </p:nvSpPr>
          <p:spPr>
            <a:xfrm>
              <a:off x="3757340" y="2613404"/>
              <a:ext cx="2000948" cy="60016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>
                  <a:latin typeface="Times New Roman"/>
                  <a:cs typeface="Times New Roman"/>
                </a:rPr>
                <a:t>POAI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100">
                  <a:latin typeface="Times New Roman"/>
                  <a:cs typeface="Times New Roman"/>
                </a:rPr>
                <a:t>n= 316 patients (316 baseline samples, 292 on-treatment) </a:t>
              </a:r>
            </a:p>
          </p:txBody>
        </p:sp>
        <p:sp>
          <p:nvSpPr>
            <p:cNvPr id="10" name="CuadroTexto 7">
              <a:extLst>
                <a:ext uri="{FF2B5EF4-FFF2-40B4-BE49-F238E27FC236}">
                  <a16:creationId xmlns:a16="http://schemas.microsoft.com/office/drawing/2014/main" id="{2D3350AB-8A6D-B8BB-2C8C-8802BEEEDBC5}"/>
                </a:ext>
              </a:extLst>
            </p:cNvPr>
            <p:cNvSpPr txBox="1"/>
            <p:nvPr/>
          </p:nvSpPr>
          <p:spPr>
            <a:xfrm>
              <a:off x="200673" y="2638433"/>
              <a:ext cx="1952836" cy="60016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>
                  <a:latin typeface="Times New Roman"/>
                  <a:cs typeface="Times New Roman"/>
                </a:rPr>
                <a:t>CONTROLS</a:t>
              </a:r>
            </a:p>
            <a:p>
              <a:pPr algn="ctr"/>
              <a:r>
                <a:rPr lang="en-GB" sz="1100">
                  <a:latin typeface="Times New Roman"/>
                  <a:cs typeface="Times New Roman"/>
                </a:rPr>
                <a:t>n= 152 patients (152 baseline samples, 148 surgery samples)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CuadroTexto 8">
              <a:extLst>
                <a:ext uri="{FF2B5EF4-FFF2-40B4-BE49-F238E27FC236}">
                  <a16:creationId xmlns:a16="http://schemas.microsoft.com/office/drawing/2014/main" id="{1AB6CF20-654B-C956-F5EE-B3C315D17142}"/>
                </a:ext>
              </a:extLst>
            </p:cNvPr>
            <p:cNvSpPr txBox="1"/>
            <p:nvPr/>
          </p:nvSpPr>
          <p:spPr>
            <a:xfrm>
              <a:off x="764553" y="3322569"/>
              <a:ext cx="2719120" cy="938718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GB" sz="1100">
                  <a:latin typeface="Times New Roman"/>
                  <a:cs typeface="Times New Roman"/>
                </a:rPr>
                <a:t>EXCLUSIONS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/>
                  <a:cs typeface="Times New Roman"/>
                </a:rPr>
                <a:t>21 no blocks, ER negative or IIT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/>
                  <a:cs typeface="Times New Roman"/>
                </a:rPr>
                <a:t>22 insufficient RNA 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/>
                  <a:cs typeface="Times New Roman"/>
                </a:rPr>
                <a:t>5 failed </a:t>
              </a:r>
              <a:r>
                <a:rPr lang="en-GB" sz="1100" err="1">
                  <a:latin typeface="Times New Roman"/>
                  <a:cs typeface="Times New Roman"/>
                </a:rPr>
                <a:t>nanostring</a:t>
              </a:r>
              <a:r>
                <a:rPr lang="en-GB" sz="1100">
                  <a:latin typeface="Times New Roman"/>
                  <a:cs typeface="Times New Roman"/>
                </a:rPr>
                <a:t> QC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/>
                  <a:cs typeface="Times New Roman"/>
                </a:rPr>
                <a:t>4 with no data at surgery timepoint</a:t>
              </a:r>
            </a:p>
          </p:txBody>
        </p:sp>
        <p:sp>
          <p:nvSpPr>
            <p:cNvPr id="12" name="CuadroTexto 9">
              <a:extLst>
                <a:ext uri="{FF2B5EF4-FFF2-40B4-BE49-F238E27FC236}">
                  <a16:creationId xmlns:a16="http://schemas.microsoft.com/office/drawing/2014/main" id="{C75A28E7-9A2B-4479-4B11-F08308CA92D2}"/>
                </a:ext>
              </a:extLst>
            </p:cNvPr>
            <p:cNvSpPr txBox="1"/>
            <p:nvPr/>
          </p:nvSpPr>
          <p:spPr>
            <a:xfrm>
              <a:off x="4101762" y="3240933"/>
              <a:ext cx="3030561" cy="93871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SIONS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56 no blocks, ER negative or IIT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17 insufficient RNA 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6 failed </a:t>
              </a:r>
              <a:r>
                <a:rPr lang="en-GB" sz="110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nostring</a:t>
              </a:r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 QC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GB" sz="1100">
                  <a:latin typeface="Times New Roman" panose="02020603050405020304" pitchFamily="18" charset="0"/>
                  <a:cs typeface="Times New Roman" panose="02020603050405020304" pitchFamily="18" charset="0"/>
                </a:rPr>
                <a:t>24 with no data at on-treatment timepoint </a:t>
              </a:r>
            </a:p>
          </p:txBody>
        </p:sp>
        <p:cxnSp>
          <p:nvCxnSpPr>
            <p:cNvPr id="13" name="Conector recto 10">
              <a:extLst>
                <a:ext uri="{FF2B5EF4-FFF2-40B4-BE49-F238E27FC236}">
                  <a16:creationId xmlns:a16="http://schemas.microsoft.com/office/drawing/2014/main" id="{FDF6A6A8-E422-48EA-EBE8-AD04B9CC75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61652" y="2360716"/>
              <a:ext cx="854197" cy="228759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Conector recto 11">
              <a:extLst>
                <a:ext uri="{FF2B5EF4-FFF2-40B4-BE49-F238E27FC236}">
                  <a16:creationId xmlns:a16="http://schemas.microsoft.com/office/drawing/2014/main" id="{B132ECCE-2A4F-30B2-02BC-B6C5F4748E41}"/>
                </a:ext>
              </a:extLst>
            </p:cNvPr>
            <p:cNvCxnSpPr>
              <a:cxnSpLocks/>
            </p:cNvCxnSpPr>
            <p:nvPr/>
          </p:nvCxnSpPr>
          <p:spPr>
            <a:xfrm>
              <a:off x="3372130" y="2295438"/>
              <a:ext cx="1073920" cy="285328"/>
            </a:xfrm>
            <a:prstGeom prst="line">
              <a:avLst/>
            </a:prstGeom>
            <a:ln w="28575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13">
              <a:extLst>
                <a:ext uri="{FF2B5EF4-FFF2-40B4-BE49-F238E27FC236}">
                  <a16:creationId xmlns:a16="http://schemas.microsoft.com/office/drawing/2014/main" id="{FA0DEEC7-AB40-F383-2808-4479F72DFDE1}"/>
                </a:ext>
              </a:extLst>
            </p:cNvPr>
            <p:cNvCxnSpPr>
              <a:cxnSpLocks/>
            </p:cNvCxnSpPr>
            <p:nvPr/>
          </p:nvCxnSpPr>
          <p:spPr>
            <a:xfrm>
              <a:off x="4087443" y="3234657"/>
              <a:ext cx="1" cy="940005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F36E23AF-79F9-6742-7059-73A168C6739B}"/>
                </a:ext>
              </a:extLst>
            </p:cNvPr>
            <p:cNvSpPr txBox="1"/>
            <p:nvPr/>
          </p:nvSpPr>
          <p:spPr>
            <a:xfrm>
              <a:off x="765665" y="5317315"/>
              <a:ext cx="3258530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 b="1">
                  <a:latin typeface="Times New Roman"/>
                  <a:cs typeface="Times New Roman"/>
                </a:rPr>
                <a:t>Total number of patients n= 313</a:t>
              </a:r>
              <a:endParaRPr lang="en-GB" sz="11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100" b="1">
                  <a:latin typeface="Times New Roman"/>
                  <a:cs typeface="Times New Roman"/>
                </a:rPr>
                <a:t>Total number of patients with paired Ki67 n= 260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A67D714F-DFD1-E3B4-96B8-9422FA99DC2B}"/>
                </a:ext>
              </a:extLst>
            </p:cNvPr>
            <p:cNvSpPr txBox="1"/>
            <p:nvPr/>
          </p:nvSpPr>
          <p:spPr>
            <a:xfrm>
              <a:off x="202922" y="4261196"/>
              <a:ext cx="1150208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>
                  <a:latin typeface="Times New Roman"/>
                  <a:cs typeface="Times New Roman"/>
                </a:rPr>
                <a:t>CONTROLS</a:t>
              </a:r>
            </a:p>
            <a:p>
              <a:pPr algn="ctr"/>
              <a:r>
                <a:rPr lang="en-GB" sz="1100">
                  <a:latin typeface="Times New Roman"/>
                  <a:cs typeface="Times New Roman"/>
                </a:rPr>
                <a:t>n= 100 patients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E1B298D8-728B-41D8-53A4-584409DBA4E0}"/>
                </a:ext>
              </a:extLst>
            </p:cNvPr>
            <p:cNvSpPr txBox="1"/>
            <p:nvPr/>
          </p:nvSpPr>
          <p:spPr>
            <a:xfrm>
              <a:off x="3463093" y="4261665"/>
              <a:ext cx="1262483" cy="430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GB" sz="1100">
                  <a:latin typeface="Times New Roman"/>
                  <a:cs typeface="Times New Roman"/>
                </a:rPr>
                <a:t>POAI</a:t>
              </a:r>
              <a:endParaRPr lang="en-US" sz="1100"/>
            </a:p>
            <a:p>
              <a:pPr algn="ctr"/>
              <a:r>
                <a:rPr lang="en-GB" sz="1100">
                  <a:latin typeface="Times New Roman"/>
                  <a:cs typeface="Times New Roman"/>
                </a:rPr>
                <a:t>n= 213 patients</a:t>
              </a:r>
              <a:endParaRPr lang="en-GB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Conector recto 21">
              <a:extLst>
                <a:ext uri="{FF2B5EF4-FFF2-40B4-BE49-F238E27FC236}">
                  <a16:creationId xmlns:a16="http://schemas.microsoft.com/office/drawing/2014/main" id="{A083C1C1-1437-B258-A870-91AADA3F3EA6}"/>
                </a:ext>
              </a:extLst>
            </p:cNvPr>
            <p:cNvCxnSpPr>
              <a:cxnSpLocks/>
            </p:cNvCxnSpPr>
            <p:nvPr/>
          </p:nvCxnSpPr>
          <p:spPr>
            <a:xfrm>
              <a:off x="718855" y="4778350"/>
              <a:ext cx="0" cy="457300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Conector recto 22">
              <a:extLst>
                <a:ext uri="{FF2B5EF4-FFF2-40B4-BE49-F238E27FC236}">
                  <a16:creationId xmlns:a16="http://schemas.microsoft.com/office/drawing/2014/main" id="{2E784559-3A53-A0C3-E306-0B19EEA72F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070166" y="4774941"/>
              <a:ext cx="5191" cy="459806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ector recto 32">
              <a:extLst>
                <a:ext uri="{FF2B5EF4-FFF2-40B4-BE49-F238E27FC236}">
                  <a16:creationId xmlns:a16="http://schemas.microsoft.com/office/drawing/2014/main" id="{1DBEC147-E232-D93F-092A-784E4C80C775}"/>
                </a:ext>
              </a:extLst>
            </p:cNvPr>
            <p:cNvCxnSpPr>
              <a:cxnSpLocks/>
            </p:cNvCxnSpPr>
            <p:nvPr/>
          </p:nvCxnSpPr>
          <p:spPr>
            <a:xfrm>
              <a:off x="2749277" y="1925836"/>
              <a:ext cx="0" cy="236123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F3670C3-62CB-41A2-BE0A-384BB9948FDB}"/>
                </a:ext>
              </a:extLst>
            </p:cNvPr>
            <p:cNvSpPr txBox="1"/>
            <p:nvPr/>
          </p:nvSpPr>
          <p:spPr>
            <a:xfrm>
              <a:off x="824749" y="4923659"/>
              <a:ext cx="2090637" cy="261610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/>
            <a:p>
              <a:r>
                <a:rPr lang="en-GB" sz="1100">
                  <a:latin typeface="Times New Roman"/>
                  <a:cs typeface="Times New Roman"/>
                </a:rPr>
                <a:t>50 patients with paired Ki67 dat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33957B1-A2D2-3EB3-443E-5DDB1B722758}"/>
                </a:ext>
              </a:extLst>
            </p:cNvPr>
            <p:cNvSpPr txBox="1"/>
            <p:nvPr/>
          </p:nvSpPr>
          <p:spPr>
            <a:xfrm>
              <a:off x="4173516" y="4883516"/>
              <a:ext cx="2215520" cy="2616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GB" sz="1100">
                  <a:latin typeface="Times New Roman"/>
                  <a:cs typeface="Times New Roman"/>
                </a:rPr>
                <a:t>210 patients with paired Ki67 data</a:t>
              </a:r>
            </a:p>
          </p:txBody>
        </p:sp>
        <p:cxnSp>
          <p:nvCxnSpPr>
            <p:cNvPr id="34" name="Conector recto 13">
              <a:extLst>
                <a:ext uri="{FF2B5EF4-FFF2-40B4-BE49-F238E27FC236}">
                  <a16:creationId xmlns:a16="http://schemas.microsoft.com/office/drawing/2014/main" id="{D2960CB3-6BD2-5FC3-9B4E-2B4168F26605}"/>
                </a:ext>
              </a:extLst>
            </p:cNvPr>
            <p:cNvCxnSpPr>
              <a:cxnSpLocks/>
            </p:cNvCxnSpPr>
            <p:nvPr/>
          </p:nvCxnSpPr>
          <p:spPr>
            <a:xfrm>
              <a:off x="742788" y="3240912"/>
              <a:ext cx="1" cy="940005"/>
            </a:xfrm>
            <a:prstGeom prst="line">
              <a:avLst/>
            </a:prstGeom>
            <a:ln w="28575"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892739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ED826046-F411-F8AE-C72B-80CE15AB301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15448163"/>
              </p:ext>
            </p:extLst>
          </p:nvPr>
        </p:nvGraphicFramePr>
        <p:xfrm>
          <a:off x="471488" y="876225"/>
          <a:ext cx="5915023" cy="797582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30051">
                  <a:extLst>
                    <a:ext uri="{9D8B030D-6E8A-4147-A177-3AD203B41FA5}">
                      <a16:colId xmlns:a16="http://schemas.microsoft.com/office/drawing/2014/main" val="2044806775"/>
                    </a:ext>
                  </a:extLst>
                </a:gridCol>
                <a:gridCol w="750932">
                  <a:extLst>
                    <a:ext uri="{9D8B030D-6E8A-4147-A177-3AD203B41FA5}">
                      <a16:colId xmlns:a16="http://schemas.microsoft.com/office/drawing/2014/main" val="2339199550"/>
                    </a:ext>
                  </a:extLst>
                </a:gridCol>
                <a:gridCol w="883510">
                  <a:extLst>
                    <a:ext uri="{9D8B030D-6E8A-4147-A177-3AD203B41FA5}">
                      <a16:colId xmlns:a16="http://schemas.microsoft.com/office/drawing/2014/main" val="3996190959"/>
                    </a:ext>
                  </a:extLst>
                </a:gridCol>
                <a:gridCol w="883510">
                  <a:extLst>
                    <a:ext uri="{9D8B030D-6E8A-4147-A177-3AD203B41FA5}">
                      <a16:colId xmlns:a16="http://schemas.microsoft.com/office/drawing/2014/main" val="3923258793"/>
                    </a:ext>
                  </a:extLst>
                </a:gridCol>
                <a:gridCol w="883510">
                  <a:extLst>
                    <a:ext uri="{9D8B030D-6E8A-4147-A177-3AD203B41FA5}">
                      <a16:colId xmlns:a16="http://schemas.microsoft.com/office/drawing/2014/main" val="1619130126"/>
                    </a:ext>
                  </a:extLst>
                </a:gridCol>
                <a:gridCol w="883510">
                  <a:extLst>
                    <a:ext uri="{9D8B030D-6E8A-4147-A177-3AD203B41FA5}">
                      <a16:colId xmlns:a16="http://schemas.microsoft.com/office/drawing/2014/main" val="2368907235"/>
                    </a:ext>
                  </a:extLst>
                </a:gridCol>
              </a:tblGrid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nature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R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ow_CI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up_CI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.value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H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8645754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F-Beta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00E-0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13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004363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optosi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0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53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7566315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C p5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8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2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·8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03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53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2608291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 T-Cell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04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5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054899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HC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0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5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1023373"/>
                  </a:ext>
                </a:extLst>
              </a:tr>
              <a:tr h="176752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mmary Stemnes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09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7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070155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-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135</a:t>
                      </a:r>
                      <a:endParaRPr lang="en-GB" sz="1800" b="0" i="0" u="none" strike="noStrike" dirty="0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7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8674801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ndothelial Cell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13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7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4138449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umA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13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7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11275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R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1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7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16696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st Cell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2218128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toxic Cell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3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6089041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audin-Low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5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521579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R2E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·6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·3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7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6220102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C Proliferatio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670513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28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82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872264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asal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·5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37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00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2149639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XA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39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01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36566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nomic Risk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44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06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8390223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otoxicity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49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12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2629844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TE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64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39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053694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roma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66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39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4564233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SR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9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7261872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BB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2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5</a:t>
                      </a:r>
                      <a:endParaRPr lang="en-GB" sz="1800" b="0" i="0" u="none" strike="noStrike" dirty="0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6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09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0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478655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ypoxia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8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7</a:t>
                      </a:r>
                      <a:endParaRPr lang="en-GB" sz="1800" b="0" i="0" u="none" strike="noStrike" dirty="0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8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12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0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53477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-L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8</a:t>
                      </a:r>
                      <a:endParaRPr lang="en-GB" sz="1800" b="0" i="0" u="none" strike="noStrike" dirty="0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1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0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9623208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ifferentiatio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7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4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19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03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302490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RD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·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85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9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3293451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187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9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14211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IGIT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07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17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559823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RCAness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5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3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2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27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8682495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M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7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93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9498369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4 Expressio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·9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13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36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0906379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D-L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32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49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4931808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7-H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5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75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93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505261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crophage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92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01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5207527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OX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20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42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7275591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umB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0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·5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39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42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4209285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K6 Expressio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3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45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42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5561123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R Signaling</a:t>
                      </a:r>
                      <a:endParaRPr lang="en-GB" sz="1800" b="0" i="0" u="none" strike="noStrike" err="1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4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5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77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9379552"/>
                  </a:ext>
                </a:extLst>
              </a:tr>
              <a:tr h="166932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flammatory Chemokines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595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23563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DO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4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06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84558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b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9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2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·2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56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022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1188300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FN Gamma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56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05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37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0971552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reg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0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6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7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625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794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743766"/>
                  </a:ext>
                </a:extLst>
              </a:tr>
              <a:tr h="166497"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1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Adhesion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98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73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·31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717</a:t>
                      </a:r>
                      <a:endParaRPr lang="en-GB" sz="1800" b="0" i="0" u="none" strike="noStrike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rtl="0" eaLnBrk="1" fontAlgn="t" latinLnBrk="0" hangingPunct="1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50" b="0" i="0" u="none" strike="noStrike" kern="120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·8717</a:t>
                      </a:r>
                      <a:endParaRPr lang="en-GB" sz="1800" b="0" i="0" u="none" strike="noStrike" dirty="0">
                        <a:effectLst/>
                        <a:latin typeface="Calibri"/>
                      </a:endParaRPr>
                    </a:p>
                  </a:txBody>
                  <a:tcPr marL="53594" marR="53594" marT="9525" marB="0">
                    <a:lnL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5A5A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360569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D2F8DD6-12C0-0AB6-04AC-D8B3B17F6EA2}"/>
              </a:ext>
            </a:extLst>
          </p:cNvPr>
          <p:cNvSpPr txBox="1"/>
          <p:nvPr/>
        </p:nvSpPr>
        <p:spPr>
          <a:xfrm>
            <a:off x="272782" y="215489"/>
            <a:ext cx="6464325" cy="26161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sz="1100" b="1" dirty="0">
                <a:latin typeface="Times New Roman"/>
                <a:cs typeface="Times New Roman"/>
              </a:rPr>
              <a:t>Supplementary table S4.</a:t>
            </a:r>
            <a:r>
              <a:rPr lang="en-GB" sz="1100" dirty="0">
                <a:latin typeface="Times New Roman"/>
                <a:cs typeface="Times New Roman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0116909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3FE8CE5-CD34-F040-391B-78A2BEAE99B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5" t="-83" r="330" b="-469"/>
          <a:stretch/>
        </p:blipFill>
        <p:spPr>
          <a:xfrm>
            <a:off x="371481" y="1028434"/>
            <a:ext cx="5456938" cy="36943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93789EF-D44A-C2EE-5B36-4E2FE365B101}"/>
              </a:ext>
            </a:extLst>
          </p:cNvPr>
          <p:cNvSpPr txBox="1"/>
          <p:nvPr/>
        </p:nvSpPr>
        <p:spPr>
          <a:xfrm>
            <a:off x="206920" y="298008"/>
            <a:ext cx="6139182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sz="1200" b="1" dirty="0">
                <a:latin typeface="Times New Roman"/>
                <a:ea typeface="+mn-lt"/>
                <a:cs typeface="Times New Roman"/>
              </a:rPr>
              <a:t>Supplementary Figure S6. </a:t>
            </a:r>
            <a:endParaRPr lang="en-GB" sz="1200" dirty="0">
              <a:latin typeface="Times New Roman"/>
              <a:ea typeface="Calibri"/>
              <a:cs typeface="Times New Roman"/>
            </a:endParaRPr>
          </a:p>
          <a:p>
            <a:endParaRPr lang="en-GB" sz="1200" dirty="0">
              <a:latin typeface="Times New Roman"/>
              <a:ea typeface="Calibri"/>
              <a:cs typeface="Times New Roman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608029-AC9C-9707-6BA9-AF01ABEA412E}"/>
              </a:ext>
            </a:extLst>
          </p:cNvPr>
          <p:cNvSpPr txBox="1"/>
          <p:nvPr/>
        </p:nvSpPr>
        <p:spPr>
          <a:xfrm>
            <a:off x="361546" y="75448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DE8B3D-9AA6-9A33-2F63-5B8571F637B6}"/>
              </a:ext>
            </a:extLst>
          </p:cNvPr>
          <p:cNvSpPr txBox="1"/>
          <p:nvPr/>
        </p:nvSpPr>
        <p:spPr>
          <a:xfrm>
            <a:off x="362122" y="4451205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7C5B04A-8200-01D9-30CB-2B30F0D596C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3493" t="-271" r="-4915" b="-4261"/>
          <a:stretch/>
        </p:blipFill>
        <p:spPr>
          <a:xfrm>
            <a:off x="208625" y="4951651"/>
            <a:ext cx="5865360" cy="3727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782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QuadreDeText 6">
            <a:extLst>
              <a:ext uri="{FF2B5EF4-FFF2-40B4-BE49-F238E27FC236}">
                <a16:creationId xmlns:a16="http://schemas.microsoft.com/office/drawing/2014/main" id="{5FE32F16-AA10-2D1F-B46A-FBCF590E73F5}"/>
              </a:ext>
            </a:extLst>
          </p:cNvPr>
          <p:cNvSpPr txBox="1"/>
          <p:nvPr/>
        </p:nvSpPr>
        <p:spPr>
          <a:xfrm>
            <a:off x="-85344" y="-64377"/>
            <a:ext cx="5881253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table S1.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BA7C426-F883-942D-2897-B98D58088C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8076328"/>
              </p:ext>
            </p:extLst>
          </p:nvPr>
        </p:nvGraphicFramePr>
        <p:xfrm>
          <a:off x="40897" y="167271"/>
          <a:ext cx="6776202" cy="10821487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817933">
                  <a:extLst>
                    <a:ext uri="{9D8B030D-6E8A-4147-A177-3AD203B41FA5}">
                      <a16:colId xmlns:a16="http://schemas.microsoft.com/office/drawing/2014/main" val="853971879"/>
                    </a:ext>
                  </a:extLst>
                </a:gridCol>
                <a:gridCol w="817933">
                  <a:extLst>
                    <a:ext uri="{9D8B030D-6E8A-4147-A177-3AD203B41FA5}">
                      <a16:colId xmlns:a16="http://schemas.microsoft.com/office/drawing/2014/main" val="410458802"/>
                    </a:ext>
                  </a:extLst>
                </a:gridCol>
                <a:gridCol w="803399">
                  <a:extLst>
                    <a:ext uri="{9D8B030D-6E8A-4147-A177-3AD203B41FA5}">
                      <a16:colId xmlns:a16="http://schemas.microsoft.com/office/drawing/2014/main" val="1535301918"/>
                    </a:ext>
                  </a:extLst>
                </a:gridCol>
                <a:gridCol w="471496">
                  <a:extLst>
                    <a:ext uri="{9D8B030D-6E8A-4147-A177-3AD203B41FA5}">
                      <a16:colId xmlns:a16="http://schemas.microsoft.com/office/drawing/2014/main" val="3620723877"/>
                    </a:ext>
                  </a:extLst>
                </a:gridCol>
                <a:gridCol w="2431928">
                  <a:extLst>
                    <a:ext uri="{9D8B030D-6E8A-4147-A177-3AD203B41FA5}">
                      <a16:colId xmlns:a16="http://schemas.microsoft.com/office/drawing/2014/main" val="1351934120"/>
                    </a:ext>
                  </a:extLst>
                </a:gridCol>
                <a:gridCol w="1433513">
                  <a:extLst>
                    <a:ext uri="{9D8B030D-6E8A-4147-A177-3AD203B41FA5}">
                      <a16:colId xmlns:a16="http://schemas.microsoft.com/office/drawing/2014/main" val="3469247883"/>
                    </a:ext>
                  </a:extLst>
                </a:gridCol>
              </a:tblGrid>
              <a:tr h="153196"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WAY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. GEN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2942538"/>
                  </a:ext>
                </a:extLst>
              </a:tr>
              <a:tr h="191496">
                <a:tc rowSpan="4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pto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AR gen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0728721"/>
                  </a:ext>
                </a:extLst>
              </a:tr>
              <a:tr h="24894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he </a:t>
                      </a:r>
                      <a:r>
                        <a:rPr lang="en-GB" sz="80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rogen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ecepto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7765710"/>
                  </a:ext>
                </a:extLst>
              </a:tr>
              <a:tr h="1914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ERBB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991487"/>
                  </a:ext>
                </a:extLst>
              </a:tr>
              <a:tr h="2393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he progesterone recepto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3134480"/>
                  </a:ext>
                </a:extLst>
              </a:tr>
              <a:tr h="287242">
                <a:tc rowSpan="7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typ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7"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-Like Correl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PAM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-Like subtype correlation coefficient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469888"/>
                  </a:ext>
                </a:extLst>
              </a:tr>
              <a:tr h="47873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udin-Low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M12, ADM, CD44, CDC20, CLDN3, CLDN4, CLDN7, DEPDC1, HES1, HLA-DPB1, ITGA6, ITGB1, MMP3, MUC1, PIK3CD, SNAI1, SNAI2, TGFB1, THY1, TWIST1, ZEB2, ZFPM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subtype characterized by low level of luminal markers, high EM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4233335"/>
                  </a:ext>
                </a:extLst>
              </a:tr>
              <a:tr h="2393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-Enriched Correl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PAM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-Enriched subtype correlation coefficient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9650956"/>
                  </a:ext>
                </a:extLst>
              </a:tr>
              <a:tr h="24894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 A Correl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PAM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 A subtype correlation coefficient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5518561"/>
                  </a:ext>
                </a:extLst>
              </a:tr>
              <a:tr h="24894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 B Correl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PAM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B</a:t>
                      </a:r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subtype correlation coefficient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0880527"/>
                  </a:ext>
                </a:extLst>
              </a:tr>
              <a:tr h="83067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M50 Subtyp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R3B, ANLN, BAG1, BCL2, BIRC5, BLVRA, CCNB1, CCNE1, CDC20, CDC6, CDH3, CENPF, CEP55, CXXC5, EGFR, ERBB2, ESR1, EXO1, FGFR4, FOXA1, FOXC1, GPR160, GRB7, KIF2C, KRT14, KRT17, KRT5, MAPT, MDM2, MELK, MIA, MKI67, MLPH, MMP11, MYBL2, MYC, NAT1, NDC80, NUF2, ORC6, PGR, PHGDH, PTTG1, RRM2, SFRP1, SLC39A6, TMEM45B, TYMS, UBE2C, UBE2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-gene signature classifying breast cancer into 4 distinct subtyp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8850106"/>
                  </a:ext>
                </a:extLst>
              </a:tr>
              <a:tr h="2872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BC Subtyp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 identifies 4 distinct TNBC subtyp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522024"/>
                  </a:ext>
                </a:extLst>
              </a:tr>
              <a:tr h="555336"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gnosi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 Risk of Recurrenc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 PAM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gorithm containing subtype correlation and PAM50 proliferation score to estimate genomic risk of distant recurrenc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7466338"/>
                  </a:ext>
                </a:extLst>
              </a:tr>
              <a:tr h="134045">
                <a:tc rowSpan="4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 Cancer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ling Pathway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CDK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5117322"/>
                  </a:ext>
                </a:extLst>
              </a:tr>
              <a:tr h="17234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6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CDK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3522694"/>
                  </a:ext>
                </a:extLst>
              </a:tr>
              <a:tr h="49788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 Signall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CY9, ADD1, ANXA9, BORCS7, CDCA8, DDX39A, DNAJC12, EIF3B, ELOVL2, ESR1, HEMK1, IFT140, ITPR1, MAPT, NAT1, PFDN2, PGR, PTGER3, SCUBE2, SERBP1, SHMT2, SYTL4, TBC1D9, TCEAL1, TFF1, TLE3, WDR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ER mediated signalling (genes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4862281"/>
                  </a:ext>
                </a:extLst>
              </a:tr>
              <a:tr h="17234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PTE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2199533"/>
                  </a:ext>
                </a:extLst>
              </a:tr>
              <a:tr h="830679">
                <a:tc rowSpan="3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 Mutational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 mutational scor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H1B, ATAD2, AURKA, BTG2, CCNA2, CCND1CDC25B, CDC25C, CDCA7L, CDK1, CDKN1A, CDKN3, CENPF, CEP55, CKS1B, DDB2, FNBP1, FOXM1, GATA3, GGH, KIAA0040, KIF23, KIFC1, MAD2L1, MAP2K4, MCM3, MKI67, MYBL2, NCAPH2, NEO1, NPEPPS, NUDT1, POLD1, PREP, PTTG1, RFC4, RNF103, SLC39A6, TAP1, TCEAL1, TOP2A, TRIP13, TUBA4A, UBE2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xpression signature developed to predict TP53 status: higher scores refer to a mutant-like status and lower scores to a wild-type status·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4990536"/>
                  </a:ext>
                </a:extLst>
              </a:tr>
              <a:tr h="94934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nes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M, ANLN, ASPM, ATP10B, BBOX1, BLM, BRCA1, BTG2, C5orf38, CCNA2, CCNB1, CCNE1, CD68, CDC7, CDCA8, CDKN1C, CHRNA5, CRYAB, CYP4F3, DCN, DDX39A, DEPDC1, EXO1, FAM83D, FLRT3, FXYD3, GJB2, HIST1H1C, HLA-E, IL1R2, ISM1, KCNB1, KIF14, KRT6B, LEMD1, MCM2, MCM3, MME, MT1G, NEIL3, NETO2, PCNA, PKMYT1, POLD1, POLQ, RFC4, RRM2, SKA3, SPC25, ST6GALNAC2, TRIP13, TTK, TY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orms about defects in DNA damage repair-genes BRCA1 and 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8685629"/>
                  </a:ext>
                </a:extLst>
              </a:tr>
              <a:tr h="36383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10B, BLM, BRCA1, BTG2, C5orf38, CCNE1, CDCA5, CDCA8, CHRNA5, CRYAB, FXYD3, HIST1H1C, HLA-E, KIF14, LEMD1, NETO2, RFC4, TRIP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 functionally assesses HR repair status· Higher score refers to higher damage repair deficiency·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3819527"/>
                  </a:ext>
                </a:extLst>
              </a:tr>
              <a:tr h="382990">
                <a:tc rowSpan="8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 Regul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8">
                  <a:txBody>
                    <a:bodyPr/>
                    <a:lstStyle/>
                    <a:p>
                      <a:pPr lvl="0">
                        <a:buNone/>
                      </a:pPr>
                      <a:endParaRPr lang="en-GB" sz="8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 w="0">
                      <a:noFill/>
                    </a:lnL>
                    <a:lnR w="0">
                      <a:noFill/>
                    </a:lnR>
                    <a:lnT w="12700">
                      <a:solidFill>
                        <a:srgbClr val="000000"/>
                      </a:solidFill>
                    </a:lnT>
                    <a:lnB w="1270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Apoptosi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X, BCL2L1, BAD, AXIN1, BBC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Captures genes associated with apoptotic processes including pro- and antiapoptotic  gen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0174261"/>
                  </a:ext>
                </a:extLst>
              </a:tr>
              <a:tr h="26809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Prolifer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LN, CCNB1, CDC20, CENPF, CEP55, EXO1, KIF2C, MELK, MKI67, RRM2, UBE2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easures genes involved in tumour prolifer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0602713"/>
                  </a:ext>
                </a:extLst>
              </a:tr>
              <a:tr h="2872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Cell Adhe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H1, CLDN1, CLDN3, CLDN4, CLDN7, OCL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Scores samples for downregulation of tight junction gen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0953039"/>
                  </a:ext>
                </a:extLst>
              </a:tr>
              <a:tr h="49788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Differentiation Scor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R2, BMP7, CAV1, CBLC, CDH1, CEACAM6, CLDN3, CLDN7, CXADR, DDR2, ELF3, FHL1, FSTL1, GDF15, HEG1, ITGB6, JAM2, MUC1, S100A14, SFRP1, SLPI, SNAI2, TCF4, TMPRSS2, TSPAN1, VCAN, VIM, WNT5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Assigns a score of differentiation to the sample·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7027056"/>
                  </a:ext>
                </a:extLst>
              </a:tr>
              <a:tr h="2393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FOXA1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Gene encoding FOXA1 transcription facto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6053472"/>
                  </a:ext>
                </a:extLst>
              </a:tr>
              <a:tr h="287242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ammary Stemnes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V1, DDR2, FHL1, FSTL1, HEG1, JAM2, SNAI2, TCF4, VCAN, VI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Measures a cluster of EMT genes upregulated in stem-cell-like tumou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0986980"/>
                  </a:ext>
                </a:extLst>
              </a:tr>
              <a:tr h="1914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Rb1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Gene encoding retinoblastoma gen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4708102"/>
                  </a:ext>
                </a:extLst>
              </a:tr>
              <a:tr h="1531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SOX2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Gene encoding SRY-box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23688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03149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1F81466-3064-EC92-EEFE-10008FCF3E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2061799"/>
              </p:ext>
            </p:extLst>
          </p:nvPr>
        </p:nvGraphicFramePr>
        <p:xfrm>
          <a:off x="40897" y="42793"/>
          <a:ext cx="6776205" cy="5946526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930217">
                  <a:extLst>
                    <a:ext uri="{9D8B030D-6E8A-4147-A177-3AD203B41FA5}">
                      <a16:colId xmlns:a16="http://schemas.microsoft.com/office/drawing/2014/main" val="1288743491"/>
                    </a:ext>
                  </a:extLst>
                </a:gridCol>
                <a:gridCol w="913688">
                  <a:extLst>
                    <a:ext uri="{9D8B030D-6E8A-4147-A177-3AD203B41FA5}">
                      <a16:colId xmlns:a16="http://schemas.microsoft.com/office/drawing/2014/main" val="2894592811"/>
                    </a:ext>
                  </a:extLst>
                </a:gridCol>
                <a:gridCol w="536222">
                  <a:extLst>
                    <a:ext uri="{9D8B030D-6E8A-4147-A177-3AD203B41FA5}">
                      <a16:colId xmlns:a16="http://schemas.microsoft.com/office/drawing/2014/main" val="4292801794"/>
                    </a:ext>
                  </a:extLst>
                </a:gridCol>
                <a:gridCol w="2765776">
                  <a:extLst>
                    <a:ext uri="{9D8B030D-6E8A-4147-A177-3AD203B41FA5}">
                      <a16:colId xmlns:a16="http://schemas.microsoft.com/office/drawing/2014/main" val="4150198885"/>
                    </a:ext>
                  </a:extLst>
                </a:gridCol>
                <a:gridCol w="1630302">
                  <a:extLst>
                    <a:ext uri="{9D8B030D-6E8A-4147-A177-3AD203B41FA5}">
                      <a16:colId xmlns:a16="http://schemas.microsoft.com/office/drawing/2014/main" val="962210140"/>
                    </a:ext>
                  </a:extLst>
                </a:gridCol>
              </a:tblGrid>
              <a:tr h="295113"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 Metabolis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xi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M, BNIP3, PGK1, SLC2A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genes associated with reduced oxygenation in the tumou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915630"/>
                  </a:ext>
                </a:extLst>
              </a:tr>
              <a:tr h="275441">
                <a:tc rowSpan="2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l Factor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thelial 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6B, CDH5, CLEC14A, CXorf36, FAM124B, KDR, MMRN2, MYCT1, PALMD, ROBO4, TIE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genes associated with vascular tissue and angiogenesi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7762682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AM12, COL6A3, FAP, LRRC32, OLFML2B, PDGFRB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stromal components in the tumour microenvironmen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1880310"/>
                  </a:ext>
                </a:extLst>
              </a:tr>
              <a:tr h="295113"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genicit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A-1, TAPBP, TAP1, TAP2, HLA-C, HLA-B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abundance of genes in MHC Class I antigen presentation pathwa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5511573"/>
                  </a:ext>
                </a:extLst>
              </a:tr>
              <a:tr h="245927">
                <a:tc rowSpan="5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 Cell Population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-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A, CD8B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CD8+ T cells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4924769"/>
                  </a:ext>
                </a:extLst>
              </a:tr>
              <a:tr h="29511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 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W, GNLY, GZMA, GZMB, GZMH, KLRK1, NKG7, PRF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cytotoxic cells in tumour microenvironmen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858049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undanc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63, CD68, CD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macrophag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689510"/>
                  </a:ext>
                </a:extLst>
              </a:tr>
              <a:tr h="21641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t 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A3, HDC, MS4A2, TPSAB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mast 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9622357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 abundanc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reg abundance by measuring FOXP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3755266"/>
                  </a:ext>
                </a:extLst>
              </a:tr>
              <a:tr h="122964">
                <a:tc rowSpan="4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 Tumour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chanis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7-H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B7-H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6535618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O1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Indoleamine 2,3 dioxygenase 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335567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1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Program cell death ligand-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1621253"/>
                  </a:ext>
                </a:extLst>
              </a:tr>
              <a:tr h="15739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-Beta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TGF-Bet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0819422"/>
                  </a:ext>
                </a:extLst>
              </a:tr>
              <a:tr h="368891">
                <a:tc rowSpan="4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 Tumour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l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lammatory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kine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, CCL3L1, CCL4, CCL7, CCL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chemokines that recruit myeloid and lymphoid populations to tumou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1727564"/>
                  </a:ext>
                </a:extLst>
              </a:tr>
              <a:tr h="15739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 PD-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2967311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Program cell death ligand-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2772351"/>
                  </a:ext>
                </a:extLst>
              </a:tr>
              <a:tr h="36889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GIT express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 cell immunoreceptor and Ig and ITIMS domain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5764396"/>
                  </a:ext>
                </a:extLst>
              </a:tr>
              <a:tr h="245927">
                <a:tc rowSpan="4"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Tumour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 Activit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it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NLY, GZMA, GZMB, GZMH, PRF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molecules used by natural killer and CD8+ T cell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8579472"/>
                  </a:ext>
                </a:extLst>
              </a:tr>
              <a:tr h="245927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feron gamma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l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L9, CLCX10, STAT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cks the canonical response to IFN gamm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2690954"/>
                  </a:ext>
                </a:extLst>
              </a:tr>
              <a:tr h="39348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 class II </a:t>
                      </a:r>
                    </a:p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gen present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A-DMA, HLA-DPA1, HLA-DPB1, HLA-DQB1, HLA-DRA, HLA-DRB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major human leukocyte antigens involved in MHC Class II antigen presenta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2775788"/>
                  </a:ext>
                </a:extLst>
              </a:tr>
              <a:tr h="7869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5, CD27, CD274, CD276, CD8A, CMKLR1, CXCL9, CXCR6, HLA-DQA1, HLA-DRB1, HLA-E, IDO1, LAG3, NKG7, PDCD1LG2, PSMB10, STAT1, TIGI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a peripherally suppressed adaptive immune response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4392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439204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928AB8DD-2E08-8796-CDD4-440F6F7D3B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6498360"/>
              </p:ext>
            </p:extLst>
          </p:nvPr>
        </p:nvGraphicFramePr>
        <p:xfrm>
          <a:off x="187776" y="514190"/>
          <a:ext cx="6623897" cy="8991600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2088000">
                  <a:extLst>
                    <a:ext uri="{9D8B030D-6E8A-4147-A177-3AD203B41FA5}">
                      <a16:colId xmlns:a16="http://schemas.microsoft.com/office/drawing/2014/main" val="3517540559"/>
                    </a:ext>
                  </a:extLst>
                </a:gridCol>
                <a:gridCol w="1533228">
                  <a:extLst>
                    <a:ext uri="{9D8B030D-6E8A-4147-A177-3AD203B41FA5}">
                      <a16:colId xmlns:a16="http://schemas.microsoft.com/office/drawing/2014/main" val="4235835728"/>
                    </a:ext>
                  </a:extLst>
                </a:gridCol>
                <a:gridCol w="1546562">
                  <a:extLst>
                    <a:ext uri="{9D8B030D-6E8A-4147-A177-3AD203B41FA5}">
                      <a16:colId xmlns:a16="http://schemas.microsoft.com/office/drawing/2014/main" val="169263139"/>
                    </a:ext>
                  </a:extLst>
                </a:gridCol>
                <a:gridCol w="1456107">
                  <a:extLst>
                    <a:ext uri="{9D8B030D-6E8A-4147-A177-3AD203B41FA5}">
                      <a16:colId xmlns:a16="http://schemas.microsoft.com/office/drawing/2014/main" val="17154779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ALL (n=31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OAI 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(n=213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CONTROLS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n=10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9227052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Age of </a:t>
                      </a:r>
                      <a:r>
                        <a:rPr lang="es-GB" sz="1000" dirty="0" err="1">
                          <a:effectLst/>
                          <a:latin typeface="Times New Roman"/>
                          <a:cs typeface="Times New Roman"/>
                        </a:rPr>
                        <a:t>randomisation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years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2383979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50-59 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57 (18·2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6 (16·9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1 (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1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34908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0-69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46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99 (46·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47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18629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70-79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78 (24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56 (26·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2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22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7148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≥80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2 (10·2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2 (10·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10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0225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Median 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6 (50-91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6 (50-91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6 (51-90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671161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Surgery 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Tumor 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size (cm) 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40695485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≤2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25 (39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80 (37·6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5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5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76835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&gt;2 &amp; ≤5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71 (54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23 (57·7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8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8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1251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&gt;5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5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 (4·7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7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631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Median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·2 (0·8-16·5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·25 (0·8-8·40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·20 (0·8-16·5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2447553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</a:t>
                      </a: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gery 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Nodal Status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2345878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N </a:t>
                      </a:r>
                      <a:r>
                        <a:rPr lang="es-GB" sz="1000" dirty="0" err="1">
                          <a:effectLst/>
                          <a:latin typeface="Times New Roman"/>
                          <a:cs typeface="Times New Roman"/>
                        </a:rPr>
                        <a:t>negative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(N0)</a:t>
                      </a:r>
                      <a:endParaRPr lang="ca-ES" sz="10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5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 (49·2%)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</a:t>
                      </a:r>
                      <a:endParaRPr lang="ca-ES" sz="10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14 (53·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5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5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09872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N </a:t>
                      </a:r>
                      <a:r>
                        <a:rPr lang="ca-ES" sz="1000" dirty="0" err="1">
                          <a:effectLst/>
                          <a:latin typeface="Times New Roman"/>
                          <a:cs typeface="Times New Roman"/>
                        </a:rPr>
                        <a:t>positive</a:t>
                      </a: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 (N1-3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99 (31·6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63 (29·6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36 (36·0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3285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N </a:t>
                      </a:r>
                      <a:r>
                        <a:rPr lang="ca-ES" sz="1000" dirty="0" err="1">
                          <a:effectLst/>
                          <a:latin typeface="Times New Roman"/>
                          <a:cs typeface="Times New Roman"/>
                        </a:rPr>
                        <a:t>positive</a:t>
                      </a:r>
                      <a:r>
                        <a:rPr lang="ca-ES" sz="1000" dirty="0">
                          <a:effectLst/>
                          <a:latin typeface="Times New Roman"/>
                          <a:cs typeface="Times New Roman"/>
                        </a:rPr>
                        <a:t> (N4+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55 (17·6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6 (16·9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9 (19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8450010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GB" sz="10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gery 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Tumor 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Grad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697268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G1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3 (4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2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 (4·7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 (3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85697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G2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44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15 (54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9 (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65062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G3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5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9·8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88 (41·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8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68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94568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Histological Typ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4382085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ILC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5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3 (6·1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·0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2873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IDC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95 (94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99 (93·4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96 (9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·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96529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Mucinous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 (0·3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 (0·47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63003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ER status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9254952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Positiv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1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1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13 (1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100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300572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</a:t>
                      </a:r>
                      <a:r>
                        <a:rPr lang="es-GB" sz="1000" dirty="0" err="1">
                          <a:effectLst/>
                          <a:latin typeface="Times New Roman"/>
                          <a:cs typeface="Times New Roman"/>
                        </a:rPr>
                        <a:t>PgR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status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1158575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Positiv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48 (47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2 (47·9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6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9070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Negativ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23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49 (23·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24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9382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Unknown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92 (29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2 (29·1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0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0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2433633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Presurgical ET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2772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Letrozol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36 (63·9%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83204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Anastrozol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77 (36·2%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6208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No treatment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0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10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349183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Adjuvant treatment therapy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42328115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Trastuzumab + chemotherapy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8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8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60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21 (56·8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67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60395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Chemotherapy alone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3 (7·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16 (7·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7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42837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No chemotherapy nor trastuzumab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98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3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1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7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3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5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5·0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34246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Chemotherapy Unknow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4 (1·3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3 (1·4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1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603466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Adjuvant ET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21661981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 Yes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30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9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·8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209 (98·1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 (9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s-GB" sz="1000" dirty="0">
                          <a:effectLst/>
                          <a:latin typeface="Times New Roman"/>
                          <a:cs typeface="Times New Roman"/>
                        </a:rPr>
                        <a:t>·0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516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 No adjuvant endocrine therapy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4 (1·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2 (0·94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2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2·0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1770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 Unknow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3 (1·00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2 (0·94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1·0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658317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algn="l"/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Type of Adjuvant ET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anchor="ctr" horzOverflow="overflow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0" marR="0" marT="0" marB="0" anchor="ctr" horzOverflow="overflow"/>
                </a:tc>
                <a:extLst>
                  <a:ext uri="{0D108BD9-81ED-4DB2-BD59-A6C34878D82A}">
                    <a16:rowId xmlns:a16="http://schemas.microsoft.com/office/drawing/2014/main" val="34966090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Letrozole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56 (49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8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09 (51·2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47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7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99126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Anastrozole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2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8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 (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9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82 (38·5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6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 (46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/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11883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Exemestane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 (0·3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 (0·47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84093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Tamoxife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7 (2·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3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7 (3·29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0 (0·00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>
                      <a:solidFill>
                        <a:schemeClr val="tx1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19282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lvl="0" algn="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Sequential AI and tamoxife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4 (4·5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10 (4·69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4 (</a:t>
                      </a:r>
                      <a:r>
                        <a:rPr lang="es-ES" sz="1000" dirty="0">
                          <a:effectLst/>
                          <a:latin typeface="Times New Roman"/>
                          <a:cs typeface="Times New Roman"/>
                        </a:rPr>
                        <a:t>4·00</a:t>
                      </a:r>
                      <a:r>
                        <a:rPr lang="en-US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440019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Ethnicity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C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87341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White: British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286 (91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4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94 (91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92 (92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22841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White: Irish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5 (1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6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3 (1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4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2 (2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89271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GB" sz="1000">
                          <a:effectLst/>
                          <a:latin typeface="Times New Roman"/>
                          <a:cs typeface="Times New Roman"/>
                        </a:rPr>
                        <a:t>White: Any other white background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8 (2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6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6 (2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8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2 (2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56845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Black or Black British: African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0 (0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6732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 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Black or Black British: Caribbean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0 (0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7393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Mixed: White and Black Caribbea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0 (0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1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6139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Asian or Asian British: Pakistani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0 (0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68419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Chinese or other ethnic group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3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1 (0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5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0 (0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75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Not Stated / Unknown</a:t>
                      </a:r>
                    </a:p>
                  </a:txBody>
                  <a:tcPr marL="23401" marR="23401" marT="0" marB="0" anchor="ctr">
                    <a:lnL w="12700">
                      <a:solidFill>
                        <a:schemeClr val="tx1"/>
                      </a:solidFill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9 (2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9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6 (2</a:t>
                      </a:r>
                      <a:r>
                        <a:rPr lang="es-GB" sz="1000">
                          <a:effectLst/>
                          <a:latin typeface="Times New Roman"/>
                          <a:cs typeface="Times New Roman"/>
                        </a:rPr>
                        <a:t>·</a:t>
                      </a:r>
                      <a:r>
                        <a:rPr lang="en-GB" sz="1000" dirty="0">
                          <a:effectLst/>
                          <a:latin typeface="Times New Roman"/>
                          <a:cs typeface="Times New Roman"/>
                        </a:rPr>
                        <a:t>8%)</a:t>
                      </a:r>
                      <a:endParaRPr lang="en-US" sz="1000" dirty="0">
                        <a:effectLst/>
                        <a:latin typeface="Times New Roman"/>
                        <a:ea typeface="Times New Roman" panose="02020603050405020304" pitchFamily="18" charset="0"/>
                        <a:cs typeface="Times New Roman"/>
                      </a:endParaRP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effectLst/>
                          <a:latin typeface="Times New Roman"/>
                          <a:ea typeface="Times New Roman" panose="02020603050405020304" pitchFamily="18" charset="0"/>
                          <a:cs typeface="Times New Roman"/>
                        </a:rPr>
                        <a:t>3 (3%)</a:t>
                      </a:r>
                    </a:p>
                  </a:txBody>
                  <a:tcPr marL="23401" marR="2340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>
                      <a:solidFill>
                        <a:schemeClr val="tx1"/>
                      </a:solidFill>
                    </a:lnR>
                    <a:lnT w="12700">
                      <a:solidFill>
                        <a:schemeClr val="tx1"/>
                      </a:solidFill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886174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6C80FA94-DC51-04FB-1589-1983DBD957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462" y="123972"/>
            <a:ext cx="66130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>
                <a:ln>
                  <a:noFill/>
                </a:ln>
                <a:effectLst/>
                <a:latin typeface="Times New Roman"/>
                <a:ea typeface="Calibri"/>
                <a:cs typeface="Times New Roman"/>
              </a:rPr>
              <a:t>Supplementary table S2. </a:t>
            </a:r>
            <a:endParaRPr lang="en-GB" sz="1200" b="0" i="0" u="none" strike="noStrike" cap="none" normalizeH="0" baseline="0" dirty="0">
              <a:ln>
                <a:noFill/>
              </a:ln>
              <a:effectLst/>
              <a:latin typeface="Times New Roman"/>
              <a:ea typeface="Calibri"/>
              <a:cs typeface="Times New Roman"/>
            </a:endParaRPr>
          </a:p>
        </p:txBody>
      </p:sp>
      <p:sp>
        <p:nvSpPr>
          <p:cNvPr id="26" name="Rectangle 3">
            <a:extLst>
              <a:ext uri="{FF2B5EF4-FFF2-40B4-BE49-F238E27FC236}">
                <a16:creationId xmlns:a16="http://schemas.microsoft.com/office/drawing/2014/main" id="{C8390D57-911E-3932-CA83-2708CEC9F9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9863" y="2877316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s-GB" altLang="es-GB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s-GB" altLang="es-GB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GB" altLang="es-GB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70038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C47BC84-AF48-806C-81F1-2D1BF4D3CD1C}"/>
              </a:ext>
            </a:extLst>
          </p:cNvPr>
          <p:cNvSpPr/>
          <p:nvPr/>
        </p:nvSpPr>
        <p:spPr>
          <a:xfrm>
            <a:off x="112395" y="97376"/>
            <a:ext cx="6286500" cy="276999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200" b="1" dirty="0">
                <a:solidFill>
                  <a:srgbClr val="222222"/>
                </a:solidFill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S2.</a:t>
            </a:r>
            <a:r>
              <a:rPr lang="en-GB" sz="1200" dirty="0">
                <a:solidFill>
                  <a:srgbClr val="222222"/>
                </a:solidFill>
                <a:latin typeface="Times New Roman"/>
                <a:ea typeface="Times New Roman" panose="02020603050405020304" pitchFamily="18" charset="0"/>
                <a:cs typeface="Times New Roman"/>
              </a:rPr>
              <a:t> </a:t>
            </a:r>
            <a:endParaRPr lang="en-GB" sz="1200" dirty="0">
              <a:solidFill>
                <a:srgbClr val="222222"/>
              </a:solidFill>
              <a:effectLst/>
              <a:latin typeface="Times New Roman"/>
              <a:ea typeface="Times New Roman" panose="02020603050405020304" pitchFamily="18" charset="0"/>
              <a:cs typeface="Times New Roman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D1553EC-0264-668A-56E2-C62804420C06}"/>
              </a:ext>
            </a:extLst>
          </p:cNvPr>
          <p:cNvGrpSpPr/>
          <p:nvPr/>
        </p:nvGrpSpPr>
        <p:grpSpPr>
          <a:xfrm>
            <a:off x="31329" y="366594"/>
            <a:ext cx="6470067" cy="8528824"/>
            <a:chOff x="103614" y="1134151"/>
            <a:chExt cx="6470067" cy="8528824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490250D-DAC4-6F3D-410B-9A5E5FDF8C16}"/>
                </a:ext>
              </a:extLst>
            </p:cNvPr>
            <p:cNvGrpSpPr/>
            <p:nvPr/>
          </p:nvGrpSpPr>
          <p:grpSpPr>
            <a:xfrm>
              <a:off x="388307" y="1134151"/>
              <a:ext cx="6185374" cy="8251825"/>
              <a:chOff x="1024720" y="994558"/>
              <a:chExt cx="4922178" cy="7768011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302E9F37-BE82-3B09-CEFA-CDDFB765F5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8" b="41295"/>
              <a:stretch/>
            </p:blipFill>
            <p:spPr>
              <a:xfrm>
                <a:off x="1024720" y="994558"/>
                <a:ext cx="4885355" cy="7768011"/>
              </a:xfrm>
              <a:prstGeom prst="rect">
                <a:avLst/>
              </a:prstGeom>
            </p:spPr>
          </p:pic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6E98F13E-F316-1CAF-33C2-838823B2F570}"/>
                  </a:ext>
                </a:extLst>
              </p:cNvPr>
              <p:cNvSpPr/>
              <p:nvPr/>
            </p:nvSpPr>
            <p:spPr>
              <a:xfrm>
                <a:off x="3504436" y="7671141"/>
                <a:ext cx="2442462" cy="10914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FDB3BDD-98FE-2D45-29B1-CFDC341422E5}"/>
                </a:ext>
              </a:extLst>
            </p:cNvPr>
            <p:cNvSpPr txBox="1"/>
            <p:nvPr/>
          </p:nvSpPr>
          <p:spPr>
            <a:xfrm rot="16200000">
              <a:off x="-439003" y="4822194"/>
              <a:ext cx="1346844" cy="261610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/>
            <a:p>
              <a:r>
                <a:rPr lang="en-GB" sz="1100" dirty="0">
                  <a:latin typeface="Arial"/>
                  <a:cs typeface="Arial"/>
                </a:rPr>
                <a:t>Log2 Fold Change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E702B0C-CC01-984C-1E86-61610C2BBCAE}"/>
                </a:ext>
              </a:extLst>
            </p:cNvPr>
            <p:cNvSpPr txBox="1"/>
            <p:nvPr/>
          </p:nvSpPr>
          <p:spPr>
            <a:xfrm>
              <a:off x="2567517" y="9385976"/>
              <a:ext cx="17347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/>
                  <a:cs typeface="Arial"/>
                </a:rPr>
                <a:t>Ki67 Change Categor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285806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B5C39D53-31E3-55DF-94B2-D15821B8E96D}"/>
              </a:ext>
            </a:extLst>
          </p:cNvPr>
          <p:cNvSpPr txBox="1"/>
          <p:nvPr/>
        </p:nvSpPr>
        <p:spPr>
          <a:xfrm>
            <a:off x="186356" y="140774"/>
            <a:ext cx="6477883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GB" sz="1200" b="1" noProof="0" dirty="0">
                <a:latin typeface="Times New Roman"/>
                <a:cs typeface="Times New Roman"/>
              </a:rPr>
              <a:t>Supplementary table S3.</a:t>
            </a:r>
            <a:r>
              <a:rPr lang="en-GB" sz="1200" noProof="0" dirty="0">
                <a:latin typeface="Times New Roman"/>
                <a:cs typeface="Times New Roman"/>
              </a:rPr>
              <a:t> </a:t>
            </a:r>
          </a:p>
        </p:txBody>
      </p:sp>
      <p:graphicFrame>
        <p:nvGraphicFramePr>
          <p:cNvPr id="4" name="Taula 3">
            <a:extLst>
              <a:ext uri="{FF2B5EF4-FFF2-40B4-BE49-F238E27FC236}">
                <a16:creationId xmlns:a16="http://schemas.microsoft.com/office/drawing/2014/main" id="{04DCAE2A-7ED7-5DCE-8BDC-D8C1F753FA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22862696"/>
              </p:ext>
            </p:extLst>
          </p:nvPr>
        </p:nvGraphicFramePr>
        <p:xfrm>
          <a:off x="669725" y="551529"/>
          <a:ext cx="5511143" cy="8430758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873642">
                  <a:extLst>
                    <a:ext uri="{9D8B030D-6E8A-4147-A177-3AD203B41FA5}">
                      <a16:colId xmlns:a16="http://schemas.microsoft.com/office/drawing/2014/main" val="4211634273"/>
                    </a:ext>
                  </a:extLst>
                </a:gridCol>
                <a:gridCol w="552549">
                  <a:extLst>
                    <a:ext uri="{9D8B030D-6E8A-4147-A177-3AD203B41FA5}">
                      <a16:colId xmlns:a16="http://schemas.microsoft.com/office/drawing/2014/main" val="3836344122"/>
                    </a:ext>
                  </a:extLst>
                </a:gridCol>
                <a:gridCol w="771238">
                  <a:extLst>
                    <a:ext uri="{9D8B030D-6E8A-4147-A177-3AD203B41FA5}">
                      <a16:colId xmlns:a16="http://schemas.microsoft.com/office/drawing/2014/main" val="450119832"/>
                    </a:ext>
                  </a:extLst>
                </a:gridCol>
                <a:gridCol w="771238">
                  <a:extLst>
                    <a:ext uri="{9D8B030D-6E8A-4147-A177-3AD203B41FA5}">
                      <a16:colId xmlns:a16="http://schemas.microsoft.com/office/drawing/2014/main" val="3203475748"/>
                    </a:ext>
                  </a:extLst>
                </a:gridCol>
                <a:gridCol w="771238">
                  <a:extLst>
                    <a:ext uri="{9D8B030D-6E8A-4147-A177-3AD203B41FA5}">
                      <a16:colId xmlns:a16="http://schemas.microsoft.com/office/drawing/2014/main" val="3312689672"/>
                    </a:ext>
                  </a:extLst>
                </a:gridCol>
                <a:gridCol w="771238">
                  <a:extLst>
                    <a:ext uri="{9D8B030D-6E8A-4147-A177-3AD203B41FA5}">
                      <a16:colId xmlns:a16="http://schemas.microsoft.com/office/drawing/2014/main" val="1466560757"/>
                    </a:ext>
                  </a:extLst>
                </a:gridCol>
              </a:tblGrid>
              <a:tr h="195167">
                <a:tc>
                  <a:txBody>
                    <a:bodyPr/>
                    <a:lstStyle/>
                    <a:p>
                      <a:pPr algn="r" fontAlgn="ctr"/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w_CI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up_CI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.value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6554301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st Cell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0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5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2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2317495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R </a:t>
                      </a:r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aling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72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66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·60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3486699"/>
                  </a:ext>
                </a:extLst>
              </a:tr>
              <a:tr h="242428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mmary Stemnes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8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3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6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319150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fferenti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80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68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·88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922533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rom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8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2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4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2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8663468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audin-Low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0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4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0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4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322522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ndothelial Cell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6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8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7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6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860320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DK6 Express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2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3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3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1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5066268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crophag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4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5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4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2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644096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TE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8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8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7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0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24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3604761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SR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57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3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27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1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27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9205841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HC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3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2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6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1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31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5083282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D-L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9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8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3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877023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G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23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1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50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3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8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0148297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GF-Be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7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1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9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5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0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5212905"/>
                  </a:ext>
                </a:extLst>
              </a:tr>
              <a:tr h="186483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flammatory Chemokine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4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4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0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5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4154491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61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9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69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05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7017612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ypoxi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8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9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5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2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2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1873960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D8 T-Cell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6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3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7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2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2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4539898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I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3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8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15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5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190338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DO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8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1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0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3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076407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ytotoxic Cell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3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4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1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3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940946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OXA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39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45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3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5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65317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D-L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9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2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9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7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9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894516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b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2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5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49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9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0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4544296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poptosis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68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3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·55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9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40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4197257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ytotoxic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4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7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23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38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0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57094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RBB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7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7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30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0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4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3232368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IGI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0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5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23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2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4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0495132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P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9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0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31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7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7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8467352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OX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2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1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20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7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7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814844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ell Adhes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8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8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51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1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0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9661044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DK4 Express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28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17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4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36057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FN Gamm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8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2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6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9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5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9369107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7-H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5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50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8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347075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re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97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66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42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6077005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D-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03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71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49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7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·88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1593065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C p5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·04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·89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6·95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·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4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179305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R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·1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·56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9·09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9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·0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5638249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omic Ris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·87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·05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1·2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·5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·9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6133493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RCAness</a:t>
                      </a:r>
                      <a:endParaRPr lang="en-GB" sz="1100" b="1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·99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55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·42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·8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·7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6063828"/>
                  </a:ext>
                </a:extLst>
              </a:tr>
              <a:tr h="195167">
                <a:tc>
                  <a:txBody>
                    <a:bodyPr/>
                    <a:lstStyle/>
                    <a:p>
                      <a:pPr algn="r" fontAlgn="ctr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C Prolifer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·25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·60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·71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·2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·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38308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758848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5">
            <a:extLst>
              <a:ext uri="{FF2B5EF4-FFF2-40B4-BE49-F238E27FC236}">
                <a16:creationId xmlns:a16="http://schemas.microsoft.com/office/drawing/2014/main" id="{4B327965-EB1E-A346-B7DE-E6F63B9153A0}"/>
              </a:ext>
            </a:extLst>
          </p:cNvPr>
          <p:cNvSpPr txBox="1"/>
          <p:nvPr/>
        </p:nvSpPr>
        <p:spPr>
          <a:xfrm>
            <a:off x="189745" y="110039"/>
            <a:ext cx="6381946" cy="93871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41910" algn="just"/>
            <a:r>
              <a:rPr lang="en-GB" sz="11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</a:t>
            </a:r>
            <a:r>
              <a:rPr lang="en-GB" sz="1100" b="1" dirty="0">
                <a:latin typeface="Times New Roman"/>
                <a:ea typeface="Times New Roman" panose="02020603050405020304" pitchFamily="18" charset="0"/>
                <a:cs typeface="Times New Roman"/>
              </a:rPr>
              <a:t>S3</a:t>
            </a:r>
            <a:r>
              <a:rPr lang="en-GB" sz="11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 </a:t>
            </a:r>
            <a:r>
              <a:rPr lang="en-GB" sz="1100" dirty="0">
                <a:latin typeface="Times New Roman"/>
                <a:ea typeface="Times New Roman" panose="02020603050405020304" pitchFamily="18" charset="0"/>
                <a:cs typeface="Times New Roman"/>
              </a:rPr>
              <a:t>Scatter plot showing the differences between 1</a:t>
            </a:r>
            <a:r>
              <a:rPr lang="en-GB" sz="11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st</a:t>
            </a:r>
            <a:r>
              <a:rPr lang="en-GB" sz="1100" dirty="0">
                <a:latin typeface="Times New Roman"/>
                <a:ea typeface="Times New Roman" panose="02020603050405020304" pitchFamily="18" charset="0"/>
                <a:cs typeface="Times New Roman"/>
              </a:rPr>
              <a:t> and 2</a:t>
            </a:r>
            <a:r>
              <a:rPr lang="en-GB" sz="11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nd</a:t>
            </a:r>
            <a:r>
              <a:rPr lang="en-GB" sz="1100" dirty="0">
                <a:latin typeface="Times New Roman"/>
                <a:ea typeface="Times New Roman" panose="02020603050405020304" pitchFamily="18" charset="0"/>
                <a:cs typeface="Times New Roman"/>
              </a:rPr>
              <a:t>  highest intrinsic subtype centroid correlation coefficients at baseline for samples that had an intrinsic subtype shifting in both a. </a:t>
            </a:r>
            <a:r>
              <a:rPr lang="en-GB" sz="1100">
                <a:latin typeface="Times New Roman"/>
                <a:ea typeface="Times New Roman" panose="02020603050405020304" pitchFamily="18" charset="0"/>
                <a:cs typeface="Times New Roman"/>
              </a:rPr>
              <a:t>POAI  and b. control groups</a:t>
            </a:r>
            <a:r>
              <a:rPr lang="en-GB" sz="110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 </a:t>
            </a:r>
            <a:r>
              <a:rPr lang="en-GB" sz="1100">
                <a:latin typeface="Times New Roman"/>
                <a:ea typeface="Times New Roman" panose="02020603050405020304" pitchFamily="18" charset="0"/>
                <a:cs typeface="Times New Roman"/>
              </a:rPr>
              <a:t>Stars represent shifting to the second highest correlation coefficient subtype. </a:t>
            </a:r>
            <a:r>
              <a:rPr lang="en-GB" sz="1100" dirty="0">
                <a:latin typeface="Times New Roman"/>
                <a:ea typeface="Times New Roman" panose="02020603050405020304" pitchFamily="18" charset="0"/>
                <a:cs typeface="Times New Roman"/>
              </a:rPr>
              <a:t>Triangles</a:t>
            </a:r>
            <a:r>
              <a:rPr lang="en-GB" sz="1100" dirty="0">
                <a:latin typeface="Times New Roman"/>
                <a:ea typeface="Times New Roman" panose="02020603050405020304" pitchFamily="18" charset="0"/>
                <a:cs typeface="Calibri"/>
              </a:rPr>
              <a:t> represent shifting towards a different subtype. The different colours represent the different IS changes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298F6AC-E117-D1C5-32FB-FBC3B1D79310}"/>
              </a:ext>
            </a:extLst>
          </p:cNvPr>
          <p:cNvSpPr txBox="1"/>
          <p:nvPr/>
        </p:nvSpPr>
        <p:spPr>
          <a:xfrm>
            <a:off x="188696" y="1307945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D82386E-4654-F719-7F5D-B497F2503C89}"/>
              </a:ext>
            </a:extLst>
          </p:cNvPr>
          <p:cNvSpPr txBox="1"/>
          <p:nvPr/>
        </p:nvSpPr>
        <p:spPr>
          <a:xfrm>
            <a:off x="203665" y="460917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7BC17C7-DD59-5493-BE1D-8B794DFE722C}"/>
              </a:ext>
            </a:extLst>
          </p:cNvPr>
          <p:cNvSpPr txBox="1"/>
          <p:nvPr/>
        </p:nvSpPr>
        <p:spPr>
          <a:xfrm>
            <a:off x="1008626" y="1409532"/>
            <a:ext cx="580608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GB" sz="1200">
                <a:latin typeface="Times New Roman"/>
                <a:cs typeface="Times New Roman"/>
              </a:rPr>
              <a:t>POAI </a:t>
            </a:r>
            <a:endParaRPr lang="en-US" sz="12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ACEEAE1-3316-7615-92FD-CDEBA376220A}"/>
              </a:ext>
            </a:extLst>
          </p:cNvPr>
          <p:cNvSpPr txBox="1"/>
          <p:nvPr/>
        </p:nvSpPr>
        <p:spPr>
          <a:xfrm>
            <a:off x="1009625" y="4698891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22B1B8-A686-516E-77C4-A62D451D5E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812" y="1646499"/>
            <a:ext cx="4584282" cy="285546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DF62FFF-4D7D-78A2-4019-5E17214F28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2813" y="5203150"/>
            <a:ext cx="4671744" cy="3056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3281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58B9F181-33B4-30EC-3460-3CDF551666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136" y="198945"/>
            <a:ext cx="667467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S4. </a:t>
            </a:r>
            <a:endParaRPr lang="en-GB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DED363B9-E920-EDD8-2E44-EEB44B84EF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71" y="759048"/>
            <a:ext cx="6862170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12901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5">
            <a:extLst>
              <a:ext uri="{FF2B5EF4-FFF2-40B4-BE49-F238E27FC236}">
                <a16:creationId xmlns:a16="http://schemas.microsoft.com/office/drawing/2014/main" id="{CA688486-BBD8-7882-4F9E-62510BBFFE96}"/>
              </a:ext>
            </a:extLst>
          </p:cNvPr>
          <p:cNvSpPr txBox="1"/>
          <p:nvPr/>
        </p:nvSpPr>
        <p:spPr>
          <a:xfrm>
            <a:off x="94268" y="42591"/>
            <a:ext cx="6381946" cy="27699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41910" algn="just"/>
            <a:r>
              <a:rPr lang="en-GB" sz="1200" b="1">
                <a:latin typeface="Times New Roman"/>
                <a:ea typeface="Times New Roman" panose="02020603050405020304" pitchFamily="18" charset="0"/>
                <a:cs typeface="Times New Roman"/>
              </a:rPr>
              <a:t>Supplementary</a:t>
            </a:r>
            <a:r>
              <a:rPr lang="en-GB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figure </a:t>
            </a:r>
            <a:r>
              <a:rPr lang="en-GB" sz="1200" b="1">
                <a:latin typeface="Times New Roman"/>
                <a:ea typeface="Times New Roman" panose="02020603050405020304" pitchFamily="18" charset="0"/>
                <a:cs typeface="Times New Roman"/>
              </a:rPr>
              <a:t>S5</a:t>
            </a:r>
            <a:r>
              <a:rPr lang="en-GB" sz="1200" b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</a:t>
            </a:r>
            <a:endParaRPr lang="en-GB" sz="1200">
              <a:effectLst/>
              <a:latin typeface="Times New Roman"/>
              <a:ea typeface="Times New Roman" panose="02020603050405020304" pitchFamily="18" charset="0"/>
              <a:cs typeface="Times New Roman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6EFA505-524E-5D0A-09E9-4587359C1F4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3584"/>
          <a:stretch/>
        </p:blipFill>
        <p:spPr>
          <a:xfrm>
            <a:off x="141104" y="559741"/>
            <a:ext cx="6561603" cy="32384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CA2B13B-84CE-9FCC-92F4-0BFDA75E6894}"/>
              </a:ext>
            </a:extLst>
          </p:cNvPr>
          <p:cNvSpPr txBox="1"/>
          <p:nvPr/>
        </p:nvSpPr>
        <p:spPr>
          <a:xfrm>
            <a:off x="474856" y="752776"/>
            <a:ext cx="550151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GB" sz="1100" dirty="0">
                <a:latin typeface="Times New Roman"/>
                <a:cs typeface="Times New Roman"/>
              </a:rPr>
              <a:t>POAI 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642A51-679B-3657-4945-DF5332907E30}"/>
              </a:ext>
            </a:extLst>
          </p:cNvPr>
          <p:cNvSpPr txBox="1"/>
          <p:nvPr/>
        </p:nvSpPr>
        <p:spPr>
          <a:xfrm>
            <a:off x="452838" y="3734482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2B57F6-BC84-B266-E842-E4EAB78010B7}"/>
              </a:ext>
            </a:extLst>
          </p:cNvPr>
          <p:cNvSpPr txBox="1"/>
          <p:nvPr/>
        </p:nvSpPr>
        <p:spPr>
          <a:xfrm rot="16200000">
            <a:off x="336729" y="1843477"/>
            <a:ext cx="178347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g2F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65E4EB5-7DD0-CB89-C1C4-D711F127A265}"/>
              </a:ext>
            </a:extLst>
          </p:cNvPr>
          <p:cNvSpPr txBox="1"/>
          <p:nvPr/>
        </p:nvSpPr>
        <p:spPr>
          <a:xfrm>
            <a:off x="2097161" y="3327589"/>
            <a:ext cx="31558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M50 Intrinsic Subtype Shift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1F75BA-B20F-F432-09B5-ADA3CE6491F2}"/>
              </a:ext>
            </a:extLst>
          </p:cNvPr>
          <p:cNvSpPr txBox="1"/>
          <p:nvPr/>
        </p:nvSpPr>
        <p:spPr>
          <a:xfrm rot="16200000">
            <a:off x="2814266" y="1744194"/>
            <a:ext cx="163107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2FC</a:t>
            </a:r>
          </a:p>
        </p:txBody>
      </p:sp>
      <p:sp>
        <p:nvSpPr>
          <p:cNvPr id="12" name="TextBox 8">
            <a:extLst>
              <a:ext uri="{FF2B5EF4-FFF2-40B4-BE49-F238E27FC236}">
                <a16:creationId xmlns:a16="http://schemas.microsoft.com/office/drawing/2014/main" id="{60B78CA7-FD50-3981-C7B6-3E5DB07F968F}"/>
              </a:ext>
            </a:extLst>
          </p:cNvPr>
          <p:cNvSpPr txBox="1"/>
          <p:nvPr/>
        </p:nvSpPr>
        <p:spPr>
          <a:xfrm>
            <a:off x="138019" y="608693"/>
            <a:ext cx="309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0" name="TextBox 9">
            <a:extLst>
              <a:ext uri="{FF2B5EF4-FFF2-40B4-BE49-F238E27FC236}">
                <a16:creationId xmlns:a16="http://schemas.microsoft.com/office/drawing/2014/main" id="{4FEDA284-E242-3280-65B8-C5CBC5A31C3D}"/>
              </a:ext>
            </a:extLst>
          </p:cNvPr>
          <p:cNvSpPr txBox="1"/>
          <p:nvPr/>
        </p:nvSpPr>
        <p:spPr>
          <a:xfrm>
            <a:off x="155538" y="3580594"/>
            <a:ext cx="319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D1607A75-78DF-8383-E1B3-AE4F95687CA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-668" t="-2970" r="-538" b="-2543"/>
          <a:stretch/>
        </p:blipFill>
        <p:spPr>
          <a:xfrm>
            <a:off x="1293637" y="920772"/>
            <a:ext cx="4887938" cy="247925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FF563B2-4170-2DAD-AD2F-71D333CF592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1371" t="645" r="-2148" b="-1290"/>
          <a:stretch/>
        </p:blipFill>
        <p:spPr>
          <a:xfrm>
            <a:off x="1227248" y="3659758"/>
            <a:ext cx="4999685" cy="2427253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1CF414A0-E12A-0B5B-DFF5-DE92ED5CC9A0}"/>
              </a:ext>
            </a:extLst>
          </p:cNvPr>
          <p:cNvSpPr txBox="1"/>
          <p:nvPr/>
        </p:nvSpPr>
        <p:spPr>
          <a:xfrm>
            <a:off x="2182659" y="6055856"/>
            <a:ext cx="315589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M50 Intrinsic Subtype Shifts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186E32D-017F-4B73-E48F-3FEB321AB0D4}"/>
              </a:ext>
            </a:extLst>
          </p:cNvPr>
          <p:cNvSpPr txBox="1"/>
          <p:nvPr/>
        </p:nvSpPr>
        <p:spPr>
          <a:xfrm rot="16200000">
            <a:off x="294865" y="4518495"/>
            <a:ext cx="178347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og2FC</a:t>
            </a:r>
          </a:p>
        </p:txBody>
      </p:sp>
    </p:spTree>
    <p:extLst>
      <p:ext uri="{BB962C8B-B14F-4D97-AF65-F5344CB8AC3E}">
        <p14:creationId xmlns:p14="http://schemas.microsoft.com/office/powerpoint/2010/main" val="2143845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FBC04EE3E857A4CB13535A3B26E8714" ma:contentTypeVersion="4" ma:contentTypeDescription="Crea un document nou" ma:contentTypeScope="" ma:versionID="4617f9067300fc23895de27c6974bf7f">
  <xsd:schema xmlns:xsd="http://www.w3.org/2001/XMLSchema" xmlns:xs="http://www.w3.org/2001/XMLSchema" xmlns:p="http://schemas.microsoft.com/office/2006/metadata/properties" xmlns:ns2="bf4ea8bd-9b03-4010-9fae-ffcef5d40006" targetNamespace="http://schemas.microsoft.com/office/2006/metadata/properties" ma:root="true" ma:fieldsID="9a1f755ad99244995431a08745a1d492" ns2:_="">
    <xsd:import namespace="bf4ea8bd-9b03-4010-9fae-ffcef5d4000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4ea8bd-9b03-4010-9fae-ffcef5d4000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us de contingut"/>
        <xsd:element ref="dc:title" minOccurs="0" maxOccurs="1" ma:index="4" ma:displayName="Títo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BF91DEE-848E-46CF-9AC3-AC9860F05E8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f4ea8bd-9b03-4010-9fae-ffcef5d4000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6A69BBB-C54D-42BE-845B-F9EF2681505C}">
  <ds:schemaRefs>
    <ds:schemaRef ds:uri="http://schemas.microsoft.com/office/2006/documentManagement/types"/>
    <ds:schemaRef ds:uri="bf4ea8bd-9b03-4010-9fae-ffcef5d40006"/>
    <ds:schemaRef ds:uri="http://schemas.openxmlformats.org/package/2006/metadata/core-properties"/>
    <ds:schemaRef ds:uri="http://purl.org/dc/elements/1.1/"/>
    <ds:schemaRef ds:uri="http://www.w3.org/XML/1998/namespace"/>
    <ds:schemaRef ds:uri="http://schemas.microsoft.com/office/infopath/2007/PartnerControls"/>
    <ds:schemaRef ds:uri="http://schemas.microsoft.com/office/2006/metadata/properties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FBF90F24-1D45-4D54-8E19-00ADA61BF34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8</TotalTime>
  <Words>2984</Words>
  <Application>Microsoft Office PowerPoint</Application>
  <PresentationFormat>A4 (210 x 297 mm)</PresentationFormat>
  <Paragraphs>1002</Paragraphs>
  <Slides>11</Slides>
  <Notes>5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1</vt:i4>
      </vt:variant>
    </vt:vector>
  </HeadingPairs>
  <TitlesOfParts>
    <vt:vector size="12" baseType="lpstr">
      <vt:lpstr>Office Them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Ferreira Leal</dc:creator>
  <cp:lastModifiedBy>Xixuan Zhu</cp:lastModifiedBy>
  <cp:revision>540</cp:revision>
  <dcterms:created xsi:type="dcterms:W3CDTF">2021-02-23T20:31:39Z</dcterms:created>
  <dcterms:modified xsi:type="dcterms:W3CDTF">2025-06-03T09:3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FBC04EE3E857A4CB13535A3B26E8714</vt:lpwstr>
  </property>
</Properties>
</file>